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05638" cy="92916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AD3C88-D051-44F7-89C8-90C1849FD2A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BB1203-03D1-4705-8502-3703DD9A81F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3E7821-0C61-4EB5-B615-C0A95261F8D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72B32E-A924-40BA-AAA3-8F8C1F80F0A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20FB45-6BB1-4A67-81C4-7A2350EFB54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6B2878-413A-4E1E-9FE4-EFF493D7380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AB0956-D109-4A2D-ABD0-F0B266FACE1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03309F-3D26-47B1-AA7B-113EA40614A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7C017C-2192-4ED2-902A-0740254A2D5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08D101-4849-43D9-B139-F83E14D1C9B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822088-DC1E-463D-BF9F-E251847F24C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ADFFEE-8227-4C67-B482-A7FB98D7D19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9C13098-EA5F-432B-B09D-4835A1C03591}" type="slidenum"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545040" y="519120"/>
            <a:ext cx="9990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Fig. S9   lysozyme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2008080" y="2387520"/>
            <a:ext cx="2911680" cy="3481560"/>
            <a:chOff x="2008080" y="2387520"/>
            <a:chExt cx="2911680" cy="3481560"/>
          </a:xfrm>
        </p:grpSpPr>
        <p:grpSp>
          <p:nvGrpSpPr>
            <p:cNvPr id="43" name=""/>
            <p:cNvGrpSpPr/>
            <p:nvPr/>
          </p:nvGrpSpPr>
          <p:grpSpPr>
            <a:xfrm>
              <a:off x="2533680" y="5470560"/>
              <a:ext cx="1717560" cy="398520"/>
              <a:chOff x="2533680" y="5470560"/>
              <a:chExt cx="1717560" cy="398520"/>
            </a:xfrm>
          </p:grpSpPr>
          <p:sp>
            <p:nvSpPr>
              <p:cNvPr id="44" name=""/>
              <p:cNvSpPr/>
              <p:nvPr/>
            </p:nvSpPr>
            <p:spPr>
              <a:xfrm flipV="1">
                <a:off x="2533680" y="5694480"/>
                <a:ext cx="1717560" cy="6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"/>
              <p:cNvSpPr/>
              <p:nvPr/>
            </p:nvSpPr>
            <p:spPr>
              <a:xfrm flipH="1">
                <a:off x="2604960" y="5618160"/>
                <a:ext cx="244800" cy="3240"/>
              </a:xfrm>
              <a:prstGeom prst="line">
                <a:avLst/>
              </a:prstGeom>
              <a:ln w="12600">
                <a:solidFill>
                  <a:srgbClr val="ff0000"/>
                </a:solidFill>
                <a:miter/>
                <a:tailEnd len="med" type="stealth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"/>
              <p:cNvSpPr/>
              <p:nvPr/>
            </p:nvSpPr>
            <p:spPr>
              <a:xfrm>
                <a:off x="2711520" y="5470560"/>
                <a:ext cx="125280" cy="92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4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3081240" y="5776920"/>
                <a:ext cx="638280" cy="92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Times New Roman"/>
                    <a:ea typeface="宋体"/>
                  </a:rPr>
                  <a:t>110615-121854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>
                <a:off x="3148200" y="5470560"/>
                <a:ext cx="134640" cy="92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3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3594240" y="5470560"/>
                <a:ext cx="129960" cy="92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2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 flipH="1">
                <a:off x="3048120" y="5618160"/>
                <a:ext cx="242640" cy="3240"/>
              </a:xfrm>
              <a:prstGeom prst="line">
                <a:avLst/>
              </a:prstGeom>
              <a:ln w="12600">
                <a:solidFill>
                  <a:srgbClr val="ff0000"/>
                </a:solidFill>
                <a:miter/>
                <a:tailEnd len="med" type="stealth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 flipH="1">
                <a:off x="3489120" y="5618160"/>
                <a:ext cx="244440" cy="3240"/>
              </a:xfrm>
              <a:prstGeom prst="line">
                <a:avLst/>
              </a:prstGeom>
              <a:ln w="12600">
                <a:solidFill>
                  <a:srgbClr val="ff0000"/>
                </a:solidFill>
                <a:miter/>
                <a:tailEnd len="med" type="stealth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 flipH="1">
                <a:off x="3933360" y="5618160"/>
                <a:ext cx="243000" cy="3240"/>
              </a:xfrm>
              <a:prstGeom prst="line">
                <a:avLst/>
              </a:prstGeom>
              <a:ln w="12600">
                <a:solidFill>
                  <a:srgbClr val="ff0000"/>
                </a:solidFill>
                <a:miter/>
                <a:tailEnd len="med" type="stealth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4038480" y="5470560"/>
                <a:ext cx="125640" cy="92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 </a:t>
                </a: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  <a:ea typeface="宋体"/>
                  </a:rPr>
                  <a:t>1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4" name=""/>
            <p:cNvSpPr/>
            <p:nvPr/>
          </p:nvSpPr>
          <p:spPr>
            <a:xfrm>
              <a:off x="2008080" y="2887560"/>
              <a:ext cx="1090800" cy="795600"/>
            </a:xfrm>
            <a:custGeom>
              <a:avLst/>
              <a:gdLst/>
              <a:ahLst/>
              <a:rect l="l" t="t" r="r" b="b"/>
              <a:pathLst>
                <a:path w="667" h="478">
                  <a:moveTo>
                    <a:pt x="638" y="421"/>
                  </a:moveTo>
                  <a:cubicBezTo>
                    <a:pt x="667" y="364"/>
                    <a:pt x="378" y="170"/>
                    <a:pt x="286" y="105"/>
                  </a:cubicBezTo>
                  <a:cubicBezTo>
                    <a:pt x="194" y="40"/>
                    <a:pt x="135" y="0"/>
                    <a:pt x="88" y="33"/>
                  </a:cubicBezTo>
                  <a:cubicBezTo>
                    <a:pt x="41" y="66"/>
                    <a:pt x="0" y="232"/>
                    <a:pt x="4" y="301"/>
                  </a:cubicBezTo>
                  <a:cubicBezTo>
                    <a:pt x="8" y="370"/>
                    <a:pt x="8" y="426"/>
                    <a:pt x="114" y="447"/>
                  </a:cubicBezTo>
                  <a:cubicBezTo>
                    <a:pt x="220" y="468"/>
                    <a:pt x="609" y="478"/>
                    <a:pt x="638" y="421"/>
                  </a:cubicBezTo>
                  <a:close/>
                </a:path>
              </a:pathLst>
            </a:custGeom>
            <a:gradFill rotWithShape="0">
              <a:gsLst>
                <a:gs pos="0">
                  <a:srgbClr val="ffff66"/>
                </a:gs>
                <a:gs pos="100000">
                  <a:srgbClr val="ffffff"/>
                </a:gs>
              </a:gsLst>
              <a:lin ang="10800000"/>
            </a:gradFill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2133720" y="4040280"/>
              <a:ext cx="946080" cy="693720"/>
            </a:xfrm>
            <a:custGeom>
              <a:avLst/>
              <a:gdLst/>
              <a:ahLst/>
              <a:rect l="l" t="t" r="r" b="b"/>
              <a:pathLst>
                <a:path w="578" h="417">
                  <a:moveTo>
                    <a:pt x="565" y="47"/>
                  </a:moveTo>
                  <a:cubicBezTo>
                    <a:pt x="578" y="94"/>
                    <a:pt x="365" y="353"/>
                    <a:pt x="277" y="385"/>
                  </a:cubicBezTo>
                  <a:cubicBezTo>
                    <a:pt x="189" y="417"/>
                    <a:pt x="78" y="280"/>
                    <a:pt x="39" y="239"/>
                  </a:cubicBezTo>
                  <a:cubicBezTo>
                    <a:pt x="0" y="198"/>
                    <a:pt x="18" y="160"/>
                    <a:pt x="45" y="137"/>
                  </a:cubicBezTo>
                  <a:cubicBezTo>
                    <a:pt x="72" y="114"/>
                    <a:pt x="116" y="115"/>
                    <a:pt x="201" y="101"/>
                  </a:cubicBezTo>
                  <a:cubicBezTo>
                    <a:pt x="286" y="87"/>
                    <a:pt x="552" y="0"/>
                    <a:pt x="565" y="47"/>
                  </a:cubicBezTo>
                  <a:close/>
                </a:path>
              </a:pathLst>
            </a:custGeom>
            <a:gradFill rotWithShape="0">
              <a:gsLst>
                <a:gs pos="0">
                  <a:srgbClr val="ffccff"/>
                </a:gs>
                <a:gs pos="100000">
                  <a:srgbClr val="ffffff"/>
                </a:gs>
              </a:gsLst>
              <a:lin ang="8100000"/>
            </a:gradFill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3381480" y="3902040"/>
              <a:ext cx="1293480" cy="709560"/>
            </a:xfrm>
            <a:custGeom>
              <a:avLst/>
              <a:gdLst/>
              <a:ahLst/>
              <a:rect l="l" t="t" r="r" b="b"/>
              <a:pathLst>
                <a:path w="792" h="426">
                  <a:moveTo>
                    <a:pt x="43" y="36"/>
                  </a:moveTo>
                  <a:cubicBezTo>
                    <a:pt x="87" y="0"/>
                    <a:pt x="578" y="70"/>
                    <a:pt x="685" y="129"/>
                  </a:cubicBezTo>
                  <a:cubicBezTo>
                    <a:pt x="792" y="188"/>
                    <a:pt x="731" y="354"/>
                    <a:pt x="687" y="390"/>
                  </a:cubicBezTo>
                  <a:cubicBezTo>
                    <a:pt x="643" y="426"/>
                    <a:pt x="529" y="407"/>
                    <a:pt x="421" y="348"/>
                  </a:cubicBezTo>
                  <a:cubicBezTo>
                    <a:pt x="313" y="289"/>
                    <a:pt x="0" y="77"/>
                    <a:pt x="43" y="36"/>
                  </a:cubicBezTo>
                  <a:close/>
                </a:path>
              </a:pathLst>
            </a:custGeom>
            <a:gradFill rotWithShape="0">
              <a:gsLst>
                <a:gs pos="0">
                  <a:srgbClr val="ffffff"/>
                </a:gs>
                <a:gs pos="100000">
                  <a:srgbClr val="ffccff"/>
                </a:gs>
              </a:gsLst>
              <a:lin ang="10800000"/>
            </a:gradFill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3197160" y="2387520"/>
              <a:ext cx="779400" cy="1308240"/>
            </a:xfrm>
            <a:custGeom>
              <a:avLst/>
              <a:gdLst/>
              <a:ahLst/>
              <a:rect l="l" t="t" r="r" b="b"/>
              <a:pathLst>
                <a:path w="477" h="789">
                  <a:moveTo>
                    <a:pt x="55" y="757"/>
                  </a:moveTo>
                  <a:cubicBezTo>
                    <a:pt x="2" y="725"/>
                    <a:pt x="6" y="268"/>
                    <a:pt x="5" y="145"/>
                  </a:cubicBezTo>
                  <a:cubicBezTo>
                    <a:pt x="4" y="22"/>
                    <a:pt x="0" y="38"/>
                    <a:pt x="49" y="19"/>
                  </a:cubicBezTo>
                  <a:cubicBezTo>
                    <a:pt x="98" y="0"/>
                    <a:pt x="229" y="14"/>
                    <a:pt x="299" y="31"/>
                  </a:cubicBezTo>
                  <a:cubicBezTo>
                    <a:pt x="369" y="48"/>
                    <a:pt x="469" y="72"/>
                    <a:pt x="473" y="123"/>
                  </a:cubicBezTo>
                  <a:cubicBezTo>
                    <a:pt x="477" y="174"/>
                    <a:pt x="395" y="234"/>
                    <a:pt x="325" y="339"/>
                  </a:cubicBezTo>
                  <a:cubicBezTo>
                    <a:pt x="255" y="444"/>
                    <a:pt x="108" y="789"/>
                    <a:pt x="55" y="757"/>
                  </a:cubicBezTo>
                  <a:close/>
                </a:path>
              </a:pathLst>
            </a:custGeom>
            <a:gradFill rotWithShape="0">
              <a:gsLst>
                <a:gs pos="0">
                  <a:srgbClr val="ffffff"/>
                </a:gs>
                <a:gs pos="100000">
                  <a:srgbClr val="bbe0e3"/>
                </a:gs>
              </a:gsLst>
              <a:lin ang="5400000"/>
            </a:gradFill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2411280" y="4019400"/>
              <a:ext cx="1862280" cy="1305000"/>
            </a:xfrm>
            <a:custGeom>
              <a:avLst/>
              <a:gdLst/>
              <a:ahLst/>
              <a:rect l="l" t="t" r="r" b="b"/>
              <a:pathLst>
                <a:path w="1138" h="787">
                  <a:moveTo>
                    <a:pt x="533" y="8"/>
                  </a:moveTo>
                  <a:cubicBezTo>
                    <a:pt x="574" y="0"/>
                    <a:pt x="584" y="142"/>
                    <a:pt x="617" y="188"/>
                  </a:cubicBezTo>
                  <a:cubicBezTo>
                    <a:pt x="650" y="234"/>
                    <a:pt x="667" y="262"/>
                    <a:pt x="729" y="284"/>
                  </a:cubicBezTo>
                  <a:cubicBezTo>
                    <a:pt x="791" y="306"/>
                    <a:pt x="922" y="303"/>
                    <a:pt x="989" y="320"/>
                  </a:cubicBezTo>
                  <a:cubicBezTo>
                    <a:pt x="1056" y="337"/>
                    <a:pt x="1128" y="342"/>
                    <a:pt x="1133" y="388"/>
                  </a:cubicBezTo>
                  <a:cubicBezTo>
                    <a:pt x="1138" y="434"/>
                    <a:pt x="1090" y="534"/>
                    <a:pt x="1021" y="596"/>
                  </a:cubicBezTo>
                  <a:cubicBezTo>
                    <a:pt x="952" y="658"/>
                    <a:pt x="855" y="733"/>
                    <a:pt x="721" y="760"/>
                  </a:cubicBezTo>
                  <a:cubicBezTo>
                    <a:pt x="587" y="787"/>
                    <a:pt x="334" y="785"/>
                    <a:pt x="217" y="756"/>
                  </a:cubicBezTo>
                  <a:cubicBezTo>
                    <a:pt x="100" y="727"/>
                    <a:pt x="34" y="633"/>
                    <a:pt x="17" y="584"/>
                  </a:cubicBezTo>
                  <a:cubicBezTo>
                    <a:pt x="0" y="535"/>
                    <a:pt x="54" y="518"/>
                    <a:pt x="113" y="460"/>
                  </a:cubicBezTo>
                  <a:cubicBezTo>
                    <a:pt x="172" y="402"/>
                    <a:pt x="303" y="310"/>
                    <a:pt x="373" y="236"/>
                  </a:cubicBezTo>
                  <a:cubicBezTo>
                    <a:pt x="443" y="162"/>
                    <a:pt x="492" y="16"/>
                    <a:pt x="533" y="8"/>
                  </a:cubicBezTo>
                  <a:close/>
                </a:path>
              </a:pathLst>
            </a:custGeom>
            <a:gradFill rotWithShape="0">
              <a:gsLst>
                <a:gs pos="0">
                  <a:srgbClr val="bbe0e3"/>
                </a:gs>
                <a:gs pos="100000">
                  <a:srgbClr val="ffffff"/>
                </a:gs>
              </a:gsLst>
              <a:lin ang="5400000"/>
            </a:gradFill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3327480" y="2754360"/>
              <a:ext cx="1592280" cy="1258920"/>
            </a:xfrm>
            <a:custGeom>
              <a:avLst/>
              <a:gdLst/>
              <a:ahLst/>
              <a:rect l="l" t="t" r="r" b="b"/>
              <a:pathLst>
                <a:path w="973" h="758">
                  <a:moveTo>
                    <a:pt x="93" y="626"/>
                  </a:moveTo>
                  <a:cubicBezTo>
                    <a:pt x="0" y="526"/>
                    <a:pt x="230" y="208"/>
                    <a:pt x="293" y="110"/>
                  </a:cubicBezTo>
                  <a:cubicBezTo>
                    <a:pt x="356" y="12"/>
                    <a:pt x="379" y="0"/>
                    <a:pt x="469" y="38"/>
                  </a:cubicBezTo>
                  <a:cubicBezTo>
                    <a:pt x="559" y="76"/>
                    <a:pt x="770" y="226"/>
                    <a:pt x="833" y="338"/>
                  </a:cubicBezTo>
                  <a:cubicBezTo>
                    <a:pt x="896" y="450"/>
                    <a:pt x="973" y="662"/>
                    <a:pt x="849" y="710"/>
                  </a:cubicBezTo>
                  <a:cubicBezTo>
                    <a:pt x="725" y="758"/>
                    <a:pt x="186" y="726"/>
                    <a:pt x="93" y="626"/>
                  </a:cubicBezTo>
                  <a:close/>
                </a:path>
              </a:pathLst>
            </a:custGeom>
            <a:gradFill rotWithShape="0">
              <a:gsLst>
                <a:gs pos="0">
                  <a:srgbClr val="ffffff"/>
                </a:gs>
                <a:gs pos="100000">
                  <a:srgbClr val="ccffcc"/>
                </a:gs>
              </a:gsLst>
              <a:lin ang="8100000"/>
            </a:gradFill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 flipH="1">
              <a:off x="3301560" y="2782800"/>
              <a:ext cx="406440" cy="814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 flipH="1">
              <a:off x="3298320" y="2603520"/>
              <a:ext cx="34920" cy="996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2967120" y="2805120"/>
              <a:ext cx="285480" cy="863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2617560" y="2935440"/>
              <a:ext cx="600120" cy="706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2303280" y="3191040"/>
              <a:ext cx="258840" cy="241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 flipV="1">
              <a:off x="2343240" y="3430440"/>
              <a:ext cx="218880" cy="38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2562120" y="3429000"/>
              <a:ext cx="654120" cy="210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3216240" y="3639960"/>
              <a:ext cx="38160" cy="28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3254400" y="3668760"/>
              <a:ext cx="27000" cy="36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 flipH="1">
              <a:off x="3279600" y="3595680"/>
              <a:ext cx="22320" cy="104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3279600" y="3701880"/>
              <a:ext cx="44640" cy="187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 flipH="1">
              <a:off x="3309480" y="3889440"/>
              <a:ext cx="12600" cy="52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2368440" y="3824280"/>
              <a:ext cx="406440" cy="128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 flipV="1">
              <a:off x="2359080" y="3955680"/>
              <a:ext cx="415800" cy="95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2773440" y="3952800"/>
              <a:ext cx="465120" cy="25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 flipV="1">
              <a:off x="2367000" y="4169880"/>
              <a:ext cx="622080" cy="179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 flipV="1">
              <a:off x="2611440" y="4169880"/>
              <a:ext cx="380880" cy="366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 flipV="1">
              <a:off x="2990880" y="3978000"/>
              <a:ext cx="249120" cy="191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 flipV="1">
              <a:off x="3233520" y="3952440"/>
              <a:ext cx="65160" cy="27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 flipH="1">
              <a:off x="3298680" y="3938400"/>
              <a:ext cx="12960" cy="14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400" bIns="-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 flipH="1">
              <a:off x="3285720" y="3952800"/>
              <a:ext cx="12600" cy="112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 flipH="1">
              <a:off x="2739600" y="4064040"/>
              <a:ext cx="547560" cy="838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3286080" y="4060800"/>
              <a:ext cx="15840" cy="88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120" bIns="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 flipH="1">
              <a:off x="3041280" y="4148280"/>
              <a:ext cx="260280" cy="1029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3301920" y="4148280"/>
              <a:ext cx="176400" cy="382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 flipH="1">
              <a:off x="3413160" y="4529160"/>
              <a:ext cx="63360" cy="414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3475080" y="4529160"/>
              <a:ext cx="42840" cy="41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3519360" y="4570560"/>
              <a:ext cx="98640" cy="484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3519360" y="4572000"/>
              <a:ext cx="112680" cy="63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560" bIns="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3628800" y="4635360"/>
              <a:ext cx="168480" cy="30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3628800" y="4635360"/>
              <a:ext cx="230400" cy="87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3857400" y="4721040"/>
              <a:ext cx="19080" cy="60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3859200" y="4722840"/>
              <a:ext cx="22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3881520" y="4722840"/>
              <a:ext cx="14040" cy="27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3886200" y="4722840"/>
              <a:ext cx="17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3902040" y="4722840"/>
              <a:ext cx="11160" cy="20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 flipV="1">
              <a:off x="3902040" y="4717800"/>
              <a:ext cx="22320" cy="4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3309840" y="3938400"/>
              <a:ext cx="285840" cy="60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680" bIns="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3592440" y="4000320"/>
              <a:ext cx="617400" cy="508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3593880" y="3997440"/>
              <a:ext cx="716040" cy="171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 flipV="1">
              <a:off x="3322440" y="3723840"/>
              <a:ext cx="285840" cy="165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3606840" y="3730680"/>
              <a:ext cx="826920" cy="79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0" bIns="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 flipV="1">
              <a:off x="3605040" y="3685680"/>
              <a:ext cx="52560" cy="41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400" bIns="-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 flipV="1">
              <a:off x="3655800" y="3433680"/>
              <a:ext cx="801720" cy="255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 flipV="1">
              <a:off x="3655800" y="3296880"/>
              <a:ext cx="293760" cy="392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 flipV="1">
              <a:off x="3951360" y="3164040"/>
              <a:ext cx="242640" cy="133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 flipV="1">
              <a:off x="3951360" y="3014280"/>
              <a:ext cx="91800" cy="281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3227400" y="2489040"/>
              <a:ext cx="530280" cy="90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66"/>
                  </a:solidFill>
                  <a:latin typeface="Arial"/>
                  <a:ea typeface="宋体"/>
                </a:rPr>
                <a:t>Dm CG1675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3413160" y="2625840"/>
              <a:ext cx="512640" cy="96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66"/>
                  </a:solidFill>
                  <a:latin typeface="Arial"/>
                  <a:ea typeface="宋体"/>
                </a:rPr>
                <a:t>Dm CG16799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3971880" y="2882880"/>
              <a:ext cx="195120" cy="98280"/>
            </a:xfrm>
            <a:prstGeom prst="rect">
              <a:avLst/>
            </a:prstGeom>
            <a:solidFill>
              <a:srgbClr val="99ffcc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cc"/>
                  </a:solidFill>
                  <a:latin typeface="Arial"/>
                  <a:ea typeface="宋体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c</a:t>
              </a:r>
              <a:r>
                <a:rPr b="0" lang="en-US" sz="600" spc="-1" strike="noStrike">
                  <a:solidFill>
                    <a:srgbClr val="0000cc"/>
                  </a:solidFill>
                  <a:latin typeface="Arial"/>
                  <a:ea typeface="宋体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2</a:t>
              </a:r>
              <a:r>
                <a:rPr b="0" lang="en-US" sz="600" spc="-1" strike="noStrike">
                  <a:solidFill>
                    <a:srgbClr val="0000cc"/>
                  </a:solidFill>
                  <a:latin typeface="Arial"/>
                  <a:ea typeface="宋体"/>
                </a:rPr>
                <a:t>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2727360" y="2708280"/>
              <a:ext cx="5014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66"/>
                  </a:solidFill>
                  <a:latin typeface="Arial"/>
                  <a:ea typeface="宋体"/>
                </a:rPr>
                <a:t>Dm CG11159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2469960" y="2832120"/>
              <a:ext cx="270000" cy="101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ff0000"/>
                  </a:solidFill>
                  <a:latin typeface="Arial"/>
                  <a:ea typeface="宋体"/>
                </a:rPr>
                <a:t>Ag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r>
                <a:rPr b="0" lang="en-US" sz="600" spc="-1" strike="noStrike">
                  <a:solidFill>
                    <a:srgbClr val="ff0000"/>
                  </a:solidFill>
                  <a:latin typeface="Arial"/>
                  <a:ea typeface="宋体"/>
                </a:rPr>
                <a:t>C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2087640" y="3075120"/>
              <a:ext cx="504720" cy="9360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m GB15016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2077920" y="3483000"/>
              <a:ext cx="490680" cy="9216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m GB10231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2179440" y="3755880"/>
              <a:ext cx="21924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Ms 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2157480" y="4010040"/>
              <a:ext cx="22068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Bm 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2217600" y="4363920"/>
              <a:ext cx="255600" cy="90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ff0000"/>
                  </a:solidFill>
                  <a:latin typeface="Arial"/>
                  <a:ea typeface="宋体"/>
                </a:rPr>
                <a:t>Ag C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2435040" y="4521240"/>
              <a:ext cx="236520" cy="92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ff0000"/>
                  </a:solidFill>
                  <a:latin typeface="Arial"/>
                  <a:ea typeface="宋体"/>
                </a:rPr>
                <a:t>Ag C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2519280" y="4911840"/>
              <a:ext cx="468360" cy="93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66"/>
                  </a:solidFill>
                  <a:latin typeface="Arial"/>
                  <a:ea typeface="宋体"/>
                </a:rPr>
                <a:t>Dm CG7798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2841480" y="5194440"/>
              <a:ext cx="5065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66"/>
                  </a:solidFill>
                  <a:latin typeface="Arial"/>
                  <a:ea typeface="宋体"/>
                </a:rPr>
                <a:t>Dm CG3006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3321000" y="4975200"/>
              <a:ext cx="233280" cy="82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66"/>
                  </a:solidFill>
                  <a:latin typeface="Arial"/>
                  <a:ea typeface="宋体"/>
                </a:rPr>
                <a:t>Dm P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3544920" y="5087880"/>
              <a:ext cx="218880" cy="90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66"/>
                  </a:solidFill>
                  <a:latin typeface="Arial"/>
                  <a:ea typeface="宋体"/>
                </a:rPr>
                <a:t>Dm X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3735360" y="4946760"/>
              <a:ext cx="239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66"/>
                  </a:solidFill>
                  <a:latin typeface="Arial"/>
                  <a:ea typeface="宋体"/>
                </a:rPr>
                <a:t>Dm 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3848040" y="4817880"/>
              <a:ext cx="271440" cy="96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66"/>
                  </a:solidFill>
                  <a:latin typeface="Arial"/>
                  <a:ea typeface="宋体"/>
                </a:rPr>
                <a:t>Dm E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3941640" y="4759200"/>
              <a:ext cx="233280" cy="90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66"/>
                  </a:solidFill>
                  <a:latin typeface="Arial"/>
                  <a:ea typeface="宋体"/>
                </a:rPr>
                <a:t>Dm B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4000320" y="4687920"/>
              <a:ext cx="238320" cy="93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66"/>
                  </a:solidFill>
                  <a:latin typeface="Arial"/>
                  <a:ea typeface="宋体"/>
                </a:rPr>
                <a:t>Dm D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4049640" y="4618080"/>
              <a:ext cx="233280" cy="102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66"/>
                  </a:solidFill>
                  <a:latin typeface="Arial"/>
                  <a:ea typeface="宋体"/>
                </a:rPr>
                <a:t>Dm C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4227480" y="4433760"/>
              <a:ext cx="288720" cy="115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ff0000"/>
                  </a:solidFill>
                  <a:latin typeface="Arial"/>
                  <a:ea typeface="宋体"/>
                </a:rPr>
                <a:t>Ag C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4324320" y="4146480"/>
              <a:ext cx="274680" cy="101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ff0000"/>
                  </a:solidFill>
                  <a:latin typeface="Arial"/>
                  <a:ea typeface="宋体"/>
                </a:rPr>
                <a:t>Ag C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4460760" y="3753000"/>
              <a:ext cx="195480" cy="98280"/>
            </a:xfrm>
            <a:prstGeom prst="rect">
              <a:avLst/>
            </a:prstGeom>
            <a:solidFill>
              <a:srgbClr val="99ffcc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c 1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4486320" y="3362400"/>
              <a:ext cx="195120" cy="98280"/>
            </a:xfrm>
            <a:prstGeom prst="rect">
              <a:avLst/>
            </a:prstGeom>
            <a:solidFill>
              <a:srgbClr val="99ffcc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c 4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4226040" y="3110040"/>
              <a:ext cx="195120" cy="99720"/>
            </a:xfrm>
            <a:prstGeom prst="rect">
              <a:avLst/>
            </a:prstGeom>
            <a:solidFill>
              <a:srgbClr val="99ffcc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c 3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 flipH="1" flipV="1" rot="1024200">
              <a:off x="3844440" y="4676760"/>
              <a:ext cx="36720" cy="4140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 flipH="1" flipV="1" rot="8473800">
              <a:off x="3945960" y="3297960"/>
              <a:ext cx="34920" cy="3816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 rot="13808400">
              <a:off x="3478680" y="4492800"/>
              <a:ext cx="34920" cy="3960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480" bIns="-334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 rot="20725200">
              <a:off x="3595680" y="3732120"/>
              <a:ext cx="34920" cy="3960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480" bIns="-334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 rot="12426000">
              <a:off x="3633480" y="4593960"/>
              <a:ext cx="34920" cy="3816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4313160" y="5251320"/>
              <a:ext cx="3589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4444920" y="5111640"/>
              <a:ext cx="142920" cy="123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0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 flipH="1" flipV="1" rot="12757200">
              <a:off x="3557880" y="3999960"/>
              <a:ext cx="34920" cy="3852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 flipH="1" flipV="1" rot="1609200">
              <a:off x="2557800" y="3383280"/>
              <a:ext cx="34920" cy="3996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480" bIns="-334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 flipH="1" flipV="1" rot="5400000">
              <a:off x="3291840" y="3680640"/>
              <a:ext cx="33120" cy="3816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 flipH="1" flipV="1" rot="8628000">
              <a:off x="2988000" y="4169160"/>
              <a:ext cx="34920" cy="3816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 rot="11057400">
              <a:off x="2765160" y="3914280"/>
              <a:ext cx="34920" cy="3816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 rot="15295800">
              <a:off x="3295440" y="4044240"/>
              <a:ext cx="34920" cy="38160"/>
            </a:xfrm>
            <a:prstGeom prst="triangle">
              <a:avLst>
                <a:gd name="adj" fmla="val 50000"/>
              </a:avLst>
            </a:prstGeom>
            <a:solidFill>
              <a:srgbClr val="ff0066"/>
            </a:solidFill>
            <a:ln w="3240">
              <a:solidFill>
                <a:srgbClr val="ff00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 flipH="1">
              <a:off x="2257200" y="3870360"/>
              <a:ext cx="5040" cy="128520"/>
            </a:xfrm>
            <a:prstGeom prst="line">
              <a:avLst/>
            </a:prstGeom>
            <a:ln w="19080">
              <a:solidFill>
                <a:srgbClr val="0066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88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2-03T20:47:33Z</dcterms:created>
  <dc:creator>haobo</dc:creator>
  <dc:description/>
  <dc:language>en-US</dc:language>
  <cp:lastModifiedBy>Haobo Jiang</cp:lastModifiedBy>
  <dcterms:modified xsi:type="dcterms:W3CDTF">2007-08-08T18:34:32Z</dcterms:modified>
  <cp:revision>103</cp:revision>
  <dc:subject/>
  <dc:title>Slide 1</dc:title>
</cp:coreProperties>
</file>